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4219881-ED76-44B0-995C-AAF5F3AB554D}" v="10" dt="2020-12-13T21:45:51.08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12" autoAdjust="0"/>
    <p:restoredTop sz="94660"/>
  </p:normalViewPr>
  <p:slideViewPr>
    <p:cSldViewPr snapToGrid="0">
      <p:cViewPr varScale="1">
        <p:scale>
          <a:sx n="75" d="100"/>
          <a:sy n="75" d="100"/>
        </p:scale>
        <p:origin x="56" y="2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brian rush" userId="388548eb9d7e14b5" providerId="LiveId" clId="{14219881-ED76-44B0-995C-AAF5F3AB554D}"/>
    <pc:docChg chg="undo custSel delSld modSld">
      <pc:chgData name="brian rush" userId="388548eb9d7e14b5" providerId="LiveId" clId="{14219881-ED76-44B0-995C-AAF5F3AB554D}" dt="2020-12-13T22:21:08.546" v="906" actId="1076"/>
      <pc:docMkLst>
        <pc:docMk/>
      </pc:docMkLst>
      <pc:sldChg chg="del">
        <pc:chgData name="brian rush" userId="388548eb9d7e14b5" providerId="LiveId" clId="{14219881-ED76-44B0-995C-AAF5F3AB554D}" dt="2020-12-13T21:56:59.623" v="646" actId="2696"/>
        <pc:sldMkLst>
          <pc:docMk/>
          <pc:sldMk cId="1419957844" sldId="256"/>
        </pc:sldMkLst>
      </pc:sldChg>
      <pc:sldChg chg="addSp delSp modSp mod">
        <pc:chgData name="brian rush" userId="388548eb9d7e14b5" providerId="LiveId" clId="{14219881-ED76-44B0-995C-AAF5F3AB554D}" dt="2020-12-13T22:21:08.546" v="906" actId="1076"/>
        <pc:sldMkLst>
          <pc:docMk/>
          <pc:sldMk cId="3320579541" sldId="257"/>
        </pc:sldMkLst>
        <pc:spChg chg="mod">
          <ac:chgData name="brian rush" userId="388548eb9d7e14b5" providerId="LiveId" clId="{14219881-ED76-44B0-995C-AAF5F3AB554D}" dt="2020-12-13T22:14:36.032" v="831" actId="1076"/>
          <ac:spMkLst>
            <pc:docMk/>
            <pc:sldMk cId="3320579541" sldId="257"/>
            <ac:spMk id="2" creationId="{32EDA023-93F5-4CB1-BEA3-0510A020F738}"/>
          </ac:spMkLst>
        </pc:spChg>
        <pc:spChg chg="mod">
          <ac:chgData name="brian rush" userId="388548eb9d7e14b5" providerId="LiveId" clId="{14219881-ED76-44B0-995C-AAF5F3AB554D}" dt="2020-12-13T22:14:45.085" v="833" actId="1076"/>
          <ac:spMkLst>
            <pc:docMk/>
            <pc:sldMk cId="3320579541" sldId="257"/>
            <ac:spMk id="3" creationId="{973D423B-2D4A-4423-A386-4FCFD3A1A105}"/>
          </ac:spMkLst>
        </pc:spChg>
        <pc:spChg chg="del mod">
          <ac:chgData name="brian rush" userId="388548eb9d7e14b5" providerId="LiveId" clId="{14219881-ED76-44B0-995C-AAF5F3AB554D}" dt="2020-12-13T21:59:47.194" v="660" actId="478"/>
          <ac:spMkLst>
            <pc:docMk/>
            <pc:sldMk cId="3320579541" sldId="257"/>
            <ac:spMk id="4" creationId="{32462315-94CF-4267-A99C-C60194152031}"/>
          </ac:spMkLst>
        </pc:spChg>
        <pc:spChg chg="mod">
          <ac:chgData name="brian rush" userId="388548eb9d7e14b5" providerId="LiveId" clId="{14219881-ED76-44B0-995C-AAF5F3AB554D}" dt="2020-12-13T22:14:27.058" v="829" actId="1076"/>
          <ac:spMkLst>
            <pc:docMk/>
            <pc:sldMk cId="3320579541" sldId="257"/>
            <ac:spMk id="5" creationId="{50630653-ACAC-4BE3-AAFE-26B61E56098D}"/>
          </ac:spMkLst>
        </pc:spChg>
        <pc:spChg chg="mod">
          <ac:chgData name="brian rush" userId="388548eb9d7e14b5" providerId="LiveId" clId="{14219881-ED76-44B0-995C-AAF5F3AB554D}" dt="2020-12-13T22:16:57.227" v="862" actId="1076"/>
          <ac:spMkLst>
            <pc:docMk/>
            <pc:sldMk cId="3320579541" sldId="257"/>
            <ac:spMk id="6" creationId="{49C7529C-5823-4E1A-8C44-533798891594}"/>
          </ac:spMkLst>
        </pc:spChg>
        <pc:spChg chg="mod">
          <ac:chgData name="brian rush" userId="388548eb9d7e14b5" providerId="LiveId" clId="{14219881-ED76-44B0-995C-AAF5F3AB554D}" dt="2020-12-13T22:19:25.236" v="890" actId="1076"/>
          <ac:spMkLst>
            <pc:docMk/>
            <pc:sldMk cId="3320579541" sldId="257"/>
            <ac:spMk id="7" creationId="{BE2F52ED-0903-4A3E-BA73-7F86526D557D}"/>
          </ac:spMkLst>
        </pc:spChg>
        <pc:spChg chg="del mod">
          <ac:chgData name="brian rush" userId="388548eb9d7e14b5" providerId="LiveId" clId="{14219881-ED76-44B0-995C-AAF5F3AB554D}" dt="2020-12-13T21:45:52.679" v="429" actId="478"/>
          <ac:spMkLst>
            <pc:docMk/>
            <pc:sldMk cId="3320579541" sldId="257"/>
            <ac:spMk id="8" creationId="{1A0C0920-453E-4FCC-9DD3-BBC40B337FF1}"/>
          </ac:spMkLst>
        </pc:spChg>
        <pc:spChg chg="del mod">
          <ac:chgData name="brian rush" userId="388548eb9d7e14b5" providerId="LiveId" clId="{14219881-ED76-44B0-995C-AAF5F3AB554D}" dt="2020-12-13T21:45:54.904" v="430" actId="478"/>
          <ac:spMkLst>
            <pc:docMk/>
            <pc:sldMk cId="3320579541" sldId="257"/>
            <ac:spMk id="9" creationId="{2D1395AB-FB51-44D8-85B5-B81974B6D4F2}"/>
          </ac:spMkLst>
        </pc:spChg>
        <pc:spChg chg="add mod">
          <ac:chgData name="brian rush" userId="388548eb9d7e14b5" providerId="LiveId" clId="{14219881-ED76-44B0-995C-AAF5F3AB554D}" dt="2020-12-13T22:14:48.654" v="834" actId="1076"/>
          <ac:spMkLst>
            <pc:docMk/>
            <pc:sldMk cId="3320579541" sldId="257"/>
            <ac:spMk id="10" creationId="{12931B61-FBFB-456F-B893-772A7989B89C}"/>
          </ac:spMkLst>
        </pc:spChg>
        <pc:spChg chg="add mod">
          <ac:chgData name="brian rush" userId="388548eb9d7e14b5" providerId="LiveId" clId="{14219881-ED76-44B0-995C-AAF5F3AB554D}" dt="2020-12-13T22:17:02.123" v="863" actId="1076"/>
          <ac:spMkLst>
            <pc:docMk/>
            <pc:sldMk cId="3320579541" sldId="257"/>
            <ac:spMk id="11" creationId="{84A98152-728A-41FE-A872-FECE5ECD597F}"/>
          </ac:spMkLst>
        </pc:spChg>
        <pc:spChg chg="add del mod">
          <ac:chgData name="brian rush" userId="388548eb9d7e14b5" providerId="LiveId" clId="{14219881-ED76-44B0-995C-AAF5F3AB554D}" dt="2020-12-13T21:59:55.454" v="662" actId="478"/>
          <ac:spMkLst>
            <pc:docMk/>
            <pc:sldMk cId="3320579541" sldId="257"/>
            <ac:spMk id="12" creationId="{7FF12DC9-E1B6-4F50-8B03-88B3A774EC08}"/>
          </ac:spMkLst>
        </pc:spChg>
        <pc:spChg chg="add mod">
          <ac:chgData name="brian rush" userId="388548eb9d7e14b5" providerId="LiveId" clId="{14219881-ED76-44B0-995C-AAF5F3AB554D}" dt="2020-12-13T22:14:39.855" v="832" actId="1076"/>
          <ac:spMkLst>
            <pc:docMk/>
            <pc:sldMk cId="3320579541" sldId="257"/>
            <ac:spMk id="13" creationId="{55D150A8-8D59-4E59-A87B-1BA92024B267}"/>
          </ac:spMkLst>
        </pc:spChg>
        <pc:spChg chg="add mod">
          <ac:chgData name="brian rush" userId="388548eb9d7e14b5" providerId="LiveId" clId="{14219881-ED76-44B0-995C-AAF5F3AB554D}" dt="2020-12-13T22:14:30.916" v="830" actId="1076"/>
          <ac:spMkLst>
            <pc:docMk/>
            <pc:sldMk cId="3320579541" sldId="257"/>
            <ac:spMk id="14" creationId="{CAFFEDF0-C808-48C7-B48E-8AE439DF6190}"/>
          </ac:spMkLst>
        </pc:spChg>
        <pc:spChg chg="add mod">
          <ac:chgData name="brian rush" userId="388548eb9d7e14b5" providerId="LiveId" clId="{14219881-ED76-44B0-995C-AAF5F3AB554D}" dt="2020-12-13T22:19:29.746" v="891" actId="1076"/>
          <ac:spMkLst>
            <pc:docMk/>
            <pc:sldMk cId="3320579541" sldId="257"/>
            <ac:spMk id="15" creationId="{9800805E-2E43-4481-8358-576C47F8BD8B}"/>
          </ac:spMkLst>
        </pc:spChg>
        <pc:spChg chg="add mod">
          <ac:chgData name="brian rush" userId="388548eb9d7e14b5" providerId="LiveId" clId="{14219881-ED76-44B0-995C-AAF5F3AB554D}" dt="2020-12-13T22:18:35.573" v="880" actId="14100"/>
          <ac:spMkLst>
            <pc:docMk/>
            <pc:sldMk cId="3320579541" sldId="257"/>
            <ac:spMk id="16" creationId="{90D4993A-5FB7-4245-AC98-E49C0BED2F39}"/>
          </ac:spMkLst>
        </pc:spChg>
        <pc:spChg chg="add mod">
          <ac:chgData name="brian rush" userId="388548eb9d7e14b5" providerId="LiveId" clId="{14219881-ED76-44B0-995C-AAF5F3AB554D}" dt="2020-12-13T22:18:28.144" v="878" actId="1076"/>
          <ac:spMkLst>
            <pc:docMk/>
            <pc:sldMk cId="3320579541" sldId="257"/>
            <ac:spMk id="17" creationId="{22352B1B-7D43-4E81-9A90-A2152C2552B1}"/>
          </ac:spMkLst>
        </pc:spChg>
        <pc:spChg chg="add mod">
          <ac:chgData name="brian rush" userId="388548eb9d7e14b5" providerId="LiveId" clId="{14219881-ED76-44B0-995C-AAF5F3AB554D}" dt="2020-12-13T22:10:39.724" v="795" actId="1076"/>
          <ac:spMkLst>
            <pc:docMk/>
            <pc:sldMk cId="3320579541" sldId="257"/>
            <ac:spMk id="18" creationId="{90A92AB7-AF24-44FB-8FDC-1F1C5626A362}"/>
          </ac:spMkLst>
        </pc:spChg>
        <pc:spChg chg="add mod">
          <ac:chgData name="brian rush" userId="388548eb9d7e14b5" providerId="LiveId" clId="{14219881-ED76-44B0-995C-AAF5F3AB554D}" dt="2020-12-13T22:11:49.973" v="804" actId="1076"/>
          <ac:spMkLst>
            <pc:docMk/>
            <pc:sldMk cId="3320579541" sldId="257"/>
            <ac:spMk id="19" creationId="{75E95A10-1AF9-4EC2-942D-D50FC2895087}"/>
          </ac:spMkLst>
        </pc:spChg>
        <pc:spChg chg="add mod">
          <ac:chgData name="brian rush" userId="388548eb9d7e14b5" providerId="LiveId" clId="{14219881-ED76-44B0-995C-AAF5F3AB554D}" dt="2020-12-13T22:11:53.960" v="805" actId="1076"/>
          <ac:spMkLst>
            <pc:docMk/>
            <pc:sldMk cId="3320579541" sldId="257"/>
            <ac:spMk id="20" creationId="{6E12D06C-5F21-4364-B904-9C661A8623F1}"/>
          </ac:spMkLst>
        </pc:spChg>
        <pc:spChg chg="add mod">
          <ac:chgData name="brian rush" userId="388548eb9d7e14b5" providerId="LiveId" clId="{14219881-ED76-44B0-995C-AAF5F3AB554D}" dt="2020-12-13T22:11:39.182" v="802" actId="1076"/>
          <ac:spMkLst>
            <pc:docMk/>
            <pc:sldMk cId="3320579541" sldId="257"/>
            <ac:spMk id="21" creationId="{455BF8AA-78C1-43B6-85C2-23C22291E30E}"/>
          </ac:spMkLst>
        </pc:spChg>
        <pc:spChg chg="add del mod">
          <ac:chgData name="brian rush" userId="388548eb9d7e14b5" providerId="LiveId" clId="{14219881-ED76-44B0-995C-AAF5F3AB554D}" dt="2020-12-13T21:53:25.359" v="599" actId="478"/>
          <ac:spMkLst>
            <pc:docMk/>
            <pc:sldMk cId="3320579541" sldId="257"/>
            <ac:spMk id="22" creationId="{4E4547CB-1406-4432-B2C5-2965E381C074}"/>
          </ac:spMkLst>
        </pc:spChg>
        <pc:spChg chg="add mod">
          <ac:chgData name="brian rush" userId="388548eb9d7e14b5" providerId="LiveId" clId="{14219881-ED76-44B0-995C-AAF5F3AB554D}" dt="2020-12-13T22:20:59.509" v="904" actId="1076"/>
          <ac:spMkLst>
            <pc:docMk/>
            <pc:sldMk cId="3320579541" sldId="257"/>
            <ac:spMk id="23" creationId="{57A4C771-E1EE-40FF-80A3-704590616600}"/>
          </ac:spMkLst>
        </pc:spChg>
        <pc:spChg chg="add mod">
          <ac:chgData name="brian rush" userId="388548eb9d7e14b5" providerId="LiveId" clId="{14219881-ED76-44B0-995C-AAF5F3AB554D}" dt="2020-12-13T22:21:03.583" v="905" actId="1076"/>
          <ac:spMkLst>
            <pc:docMk/>
            <pc:sldMk cId="3320579541" sldId="257"/>
            <ac:spMk id="24" creationId="{C21FC4A2-67E4-4592-B13E-C15BEC3AD6C8}"/>
          </ac:spMkLst>
        </pc:spChg>
        <pc:spChg chg="add mod">
          <ac:chgData name="brian rush" userId="388548eb9d7e14b5" providerId="LiveId" clId="{14219881-ED76-44B0-995C-AAF5F3AB554D}" dt="2020-12-13T22:16:19.180" v="854" actId="1076"/>
          <ac:spMkLst>
            <pc:docMk/>
            <pc:sldMk cId="3320579541" sldId="257"/>
            <ac:spMk id="25" creationId="{47AA5273-B307-4D4A-8F41-E3A3E9336BDA}"/>
          </ac:spMkLst>
        </pc:spChg>
        <pc:spChg chg="add mod">
          <ac:chgData name="brian rush" userId="388548eb9d7e14b5" providerId="LiveId" clId="{14219881-ED76-44B0-995C-AAF5F3AB554D}" dt="2020-12-13T22:20:31.148" v="900" actId="14100"/>
          <ac:spMkLst>
            <pc:docMk/>
            <pc:sldMk cId="3320579541" sldId="257"/>
            <ac:spMk id="26" creationId="{379CFCDA-D793-41B6-8C7E-6E3FA8672568}"/>
          </ac:spMkLst>
        </pc:spChg>
        <pc:spChg chg="add mod">
          <ac:chgData name="brian rush" userId="388548eb9d7e14b5" providerId="LiveId" clId="{14219881-ED76-44B0-995C-AAF5F3AB554D}" dt="2020-12-13T22:02:07.294" v="680" actId="14100"/>
          <ac:spMkLst>
            <pc:docMk/>
            <pc:sldMk cId="3320579541" sldId="257"/>
            <ac:spMk id="27" creationId="{CF825AF0-B401-4C54-A90C-33E99491E178}"/>
          </ac:spMkLst>
        </pc:spChg>
        <pc:spChg chg="add mod">
          <ac:chgData name="brian rush" userId="388548eb9d7e14b5" providerId="LiveId" clId="{14219881-ED76-44B0-995C-AAF5F3AB554D}" dt="2020-12-13T22:16:39.127" v="858" actId="1076"/>
          <ac:spMkLst>
            <pc:docMk/>
            <pc:sldMk cId="3320579541" sldId="257"/>
            <ac:spMk id="28" creationId="{02CBCF46-FBE9-4DF5-A29A-0538A176F0B0}"/>
          </ac:spMkLst>
        </pc:spChg>
        <pc:spChg chg="add mod">
          <ac:chgData name="brian rush" userId="388548eb9d7e14b5" providerId="LiveId" clId="{14219881-ED76-44B0-995C-AAF5F3AB554D}" dt="2020-12-13T22:15:53.337" v="849" actId="1076"/>
          <ac:spMkLst>
            <pc:docMk/>
            <pc:sldMk cId="3320579541" sldId="257"/>
            <ac:spMk id="29" creationId="{24168872-20A1-40BE-B50A-FA49B122475C}"/>
          </ac:spMkLst>
        </pc:spChg>
        <pc:spChg chg="add del mod">
          <ac:chgData name="brian rush" userId="388548eb9d7e14b5" providerId="LiveId" clId="{14219881-ED76-44B0-995C-AAF5F3AB554D}" dt="2020-12-13T22:15:01.113" v="837" actId="21"/>
          <ac:spMkLst>
            <pc:docMk/>
            <pc:sldMk cId="3320579541" sldId="257"/>
            <ac:spMk id="30" creationId="{3F7451A3-A410-4C90-9893-4EDE53C6F5D2}"/>
          </ac:spMkLst>
        </pc:spChg>
        <pc:spChg chg="add mod">
          <ac:chgData name="brian rush" userId="388548eb9d7e14b5" providerId="LiveId" clId="{14219881-ED76-44B0-995C-AAF5F3AB554D}" dt="2020-12-13T22:20:52.464" v="902" actId="1076"/>
          <ac:spMkLst>
            <pc:docMk/>
            <pc:sldMk cId="3320579541" sldId="257"/>
            <ac:spMk id="31" creationId="{F0E1A044-7BE5-46D7-9AB2-159379D9C395}"/>
          </ac:spMkLst>
        </pc:spChg>
        <pc:spChg chg="add mod">
          <ac:chgData name="brian rush" userId="388548eb9d7e14b5" providerId="LiveId" clId="{14219881-ED76-44B0-995C-AAF5F3AB554D}" dt="2020-12-13T22:21:08.546" v="906" actId="1076"/>
          <ac:spMkLst>
            <pc:docMk/>
            <pc:sldMk cId="3320579541" sldId="257"/>
            <ac:spMk id="32" creationId="{A97F08C9-FED8-4C82-B7BD-AF780C278B8A}"/>
          </ac:spMkLst>
        </pc:spChg>
        <pc:spChg chg="add mod">
          <ac:chgData name="brian rush" userId="388548eb9d7e14b5" providerId="LiveId" clId="{14219881-ED76-44B0-995C-AAF5F3AB554D}" dt="2020-12-13T22:20:14.054" v="896" actId="1076"/>
          <ac:spMkLst>
            <pc:docMk/>
            <pc:sldMk cId="3320579541" sldId="257"/>
            <ac:spMk id="33" creationId="{40E41187-FCE2-44A9-8E70-D8B9E3EAA8FF}"/>
          </ac:spMkLst>
        </pc:spChg>
        <pc:spChg chg="add del mod">
          <ac:chgData name="brian rush" userId="388548eb9d7e14b5" providerId="LiveId" clId="{14219881-ED76-44B0-995C-AAF5F3AB554D}" dt="2020-12-13T22:20:43.918" v="901" actId="478"/>
          <ac:spMkLst>
            <pc:docMk/>
            <pc:sldMk cId="3320579541" sldId="257"/>
            <ac:spMk id="34" creationId="{F9268F74-F385-41C2-9258-1D7CD533C02D}"/>
          </ac:spMkLst>
        </pc:spChg>
        <pc:spChg chg="add mod">
          <ac:chgData name="brian rush" userId="388548eb9d7e14b5" providerId="LiveId" clId="{14219881-ED76-44B0-995C-AAF5F3AB554D}" dt="2020-12-13T22:18:58.481" v="884" actId="14100"/>
          <ac:spMkLst>
            <pc:docMk/>
            <pc:sldMk cId="3320579541" sldId="257"/>
            <ac:spMk id="35" creationId="{F579B330-F398-445C-A76B-C79539C2B17F}"/>
          </ac:spMkLst>
        </pc:spChg>
        <pc:spChg chg="add mod">
          <ac:chgData name="brian rush" userId="388548eb9d7e14b5" providerId="LiveId" clId="{14219881-ED76-44B0-995C-AAF5F3AB554D}" dt="2020-12-13T22:18:31.382" v="879" actId="1076"/>
          <ac:spMkLst>
            <pc:docMk/>
            <pc:sldMk cId="3320579541" sldId="257"/>
            <ac:spMk id="36" creationId="{87710EB6-32B5-467D-ACCD-8C5C5D5D6362}"/>
          </ac:spMkLst>
        </pc:spChg>
        <pc:spChg chg="add mod">
          <ac:chgData name="brian rush" userId="388548eb9d7e14b5" providerId="LiveId" clId="{14219881-ED76-44B0-995C-AAF5F3AB554D}" dt="2020-12-13T22:12:46.214" v="815" actId="14100"/>
          <ac:spMkLst>
            <pc:docMk/>
            <pc:sldMk cId="3320579541" sldId="257"/>
            <ac:spMk id="37" creationId="{E801E2A9-175D-47E9-9E38-35B873189019}"/>
          </ac:spMkLst>
        </pc:spChg>
        <pc:spChg chg="add mod">
          <ac:chgData name="brian rush" userId="388548eb9d7e14b5" providerId="LiveId" clId="{14219881-ED76-44B0-995C-AAF5F3AB554D}" dt="2020-12-13T22:12:52.793" v="816" actId="1076"/>
          <ac:spMkLst>
            <pc:docMk/>
            <pc:sldMk cId="3320579541" sldId="257"/>
            <ac:spMk id="38" creationId="{6DD7F968-8523-4ADB-A877-28231980E82F}"/>
          </ac:spMkLst>
        </pc:spChg>
        <pc:spChg chg="add mod">
          <ac:chgData name="brian rush" userId="388548eb9d7e14b5" providerId="LiveId" clId="{14219881-ED76-44B0-995C-AAF5F3AB554D}" dt="2020-12-13T22:13:37.923" v="828" actId="688"/>
          <ac:spMkLst>
            <pc:docMk/>
            <pc:sldMk cId="3320579541" sldId="257"/>
            <ac:spMk id="39" creationId="{C86689F4-8C38-45CC-968B-C0FDAFD04527}"/>
          </ac:spMkLst>
        </pc:spChg>
        <pc:spChg chg="add mod">
          <ac:chgData name="brian rush" userId="388548eb9d7e14b5" providerId="LiveId" clId="{14219881-ED76-44B0-995C-AAF5F3AB554D}" dt="2020-12-13T22:20:55.935" v="903" actId="1076"/>
          <ac:spMkLst>
            <pc:docMk/>
            <pc:sldMk cId="3320579541" sldId="257"/>
            <ac:spMk id="40" creationId="{029AFBB4-45B6-4E57-B6AC-E79C4E1A8B66}"/>
          </ac:spMkLst>
        </pc:spChg>
        <pc:spChg chg="add mod">
          <ac:chgData name="brian rush" userId="388548eb9d7e14b5" providerId="LiveId" clId="{14219881-ED76-44B0-995C-AAF5F3AB554D}" dt="2020-12-13T22:18:16.013" v="875" actId="1076"/>
          <ac:spMkLst>
            <pc:docMk/>
            <pc:sldMk cId="3320579541" sldId="257"/>
            <ac:spMk id="41" creationId="{91A21E97-A5EA-419F-B0BB-20AFC258DFE0}"/>
          </ac:spMkLst>
        </pc:spChg>
        <pc:spChg chg="add mod">
          <ac:chgData name="brian rush" userId="388548eb9d7e14b5" providerId="LiveId" clId="{14219881-ED76-44B0-995C-AAF5F3AB554D}" dt="2020-12-13T22:20:00.582" v="894" actId="1076"/>
          <ac:spMkLst>
            <pc:docMk/>
            <pc:sldMk cId="3320579541" sldId="257"/>
            <ac:spMk id="42" creationId="{9831CA40-82B0-4176-B996-45005FD24E2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1F09C8-96E3-4BFB-AB56-CD149F56403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22FDDD7-1E56-4A98-BB2F-EEC4AB6AFE8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5653D7-5729-445A-BF0E-9C31975226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421A0-B32E-4A6A-A3FA-72BD297CDE5B}" type="datetimeFigureOut">
              <a:rPr lang="en-CA" smtClean="0"/>
              <a:t>2020-12-13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3A352E-B3AE-4AE4-A72F-30E2FAAB4A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ADFA0B-058C-485C-9019-A185C2DB88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E4E48F-5569-4F35-A202-B4371EAE21F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172308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781E2E-4FC8-4613-9BE8-B55B811998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3AE26EE-9F5B-4184-9AC5-D4EF5EA437E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138882-3C58-4D00-AE59-505C22EDA7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421A0-B32E-4A6A-A3FA-72BD297CDE5B}" type="datetimeFigureOut">
              <a:rPr lang="en-CA" smtClean="0"/>
              <a:t>2020-12-13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E0039E-6384-421C-A573-29E3DD3AF5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F1F34F-26E5-4A0E-AB19-14AE7E1971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E4E48F-5569-4F35-A202-B4371EAE21F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615303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C084CD6-1382-4F1A-AC26-4CF0FB98129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0FEE2D9-D35D-4EA4-B52B-19C7D5C078E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C3AC80-77BB-45BB-A98A-E6AA80E7C2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421A0-B32E-4A6A-A3FA-72BD297CDE5B}" type="datetimeFigureOut">
              <a:rPr lang="en-CA" smtClean="0"/>
              <a:t>2020-12-13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6A0451-00CA-473F-983D-B4E6636D1B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9C5FC3-6A75-47E4-AA08-2EEB6BEC8A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E4E48F-5569-4F35-A202-B4371EAE21F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21613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0BA65B-F1C6-43C8-9473-2006958810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3F46085-432C-4E46-B970-9F1BA00F234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FDD9D6-ABC1-414B-AF22-B43BE056BE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421A0-B32E-4A6A-A3FA-72BD297CDE5B}" type="datetimeFigureOut">
              <a:rPr lang="en-CA" smtClean="0"/>
              <a:t>2020-12-13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F60885-A0C2-44B7-B43A-E95BE2047B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57E1D8E-D19C-4FE7-B05F-ECEDE9B54C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E4E48F-5569-4F35-A202-B4371EAE21F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94225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EC7FD0-DCD9-49B9-8737-CB5F15E34B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54C5F30-B805-4BF7-A995-D1B6D01105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40640D0-EC1F-4193-8B6B-9E9FC33F3B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421A0-B32E-4A6A-A3FA-72BD297CDE5B}" type="datetimeFigureOut">
              <a:rPr lang="en-CA" smtClean="0"/>
              <a:t>2020-12-13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49BDFD-7ED0-4A9F-AD8F-592EA6E67F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CB63C5-9DEC-4086-B3C1-03F66074FF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E4E48F-5569-4F35-A202-B4371EAE21F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719777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091DCC-B0B8-4E96-AF93-52A386E364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1F35A60-660C-4775-8E88-A028469398E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C4B98B8-C7F5-4FB9-B19F-3DB9F865550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74C6D12-8B91-408F-9C8C-9507D9FE8B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421A0-B32E-4A6A-A3FA-72BD297CDE5B}" type="datetimeFigureOut">
              <a:rPr lang="en-CA" smtClean="0"/>
              <a:t>2020-12-13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92C0C13-035D-4E1B-A07D-299757B951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A52508A-D58D-414F-90BE-9BA98405E8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E4E48F-5569-4F35-A202-B4371EAE21F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630511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AE3BE8-8C90-4436-A27E-98AA47762C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528040D-CBD4-4468-8BB0-DF679A4875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36A082D-B561-445C-8227-ECAE931DFB6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495BB10-D6C4-4857-BDC0-44D0742EAB4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288CB1A-E38D-4788-B6A6-2792CFAE675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8B5E7B0-59CD-4834-8EB7-C7018189B2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421A0-B32E-4A6A-A3FA-72BD297CDE5B}" type="datetimeFigureOut">
              <a:rPr lang="en-CA" smtClean="0"/>
              <a:t>2020-12-13</a:t>
            </a:fld>
            <a:endParaRPr lang="en-C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D80B9BF-2D7A-4E77-B57C-0953F550EC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6150A7F-F970-48DB-B364-38683C6340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E4E48F-5569-4F35-A202-B4371EAE21F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857200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1F3448-7AD3-413B-8610-CC3AAB344B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DA1DF61-D701-4E3F-899B-5B767279B1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421A0-B32E-4A6A-A3FA-72BD297CDE5B}" type="datetimeFigureOut">
              <a:rPr lang="en-CA" smtClean="0"/>
              <a:t>2020-12-13</a:t>
            </a:fld>
            <a:endParaRPr lang="en-C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B39B13B-6A66-4752-99D1-2E7844F5BE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7F18D22-3843-4550-BE98-05FB3FEC2E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E4E48F-5569-4F35-A202-B4371EAE21F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831320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E1DB556-226F-4FC3-8FFC-B589A4B002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421A0-B32E-4A6A-A3FA-72BD297CDE5B}" type="datetimeFigureOut">
              <a:rPr lang="en-CA" smtClean="0"/>
              <a:t>2020-12-13</a:t>
            </a:fld>
            <a:endParaRPr lang="en-C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A49902C-A737-4F0D-A847-B15D1476D6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F7AD0C5-CB8B-4A55-9564-F809E97225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E4E48F-5569-4F35-A202-B4371EAE21F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720906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BCE617-3704-4F8A-AAA2-2A30B2FC19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31463BB-9C51-4DED-923C-1305F1C7A5D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0A9D5A2-253B-426E-9957-DA82A1792DF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9CDEFB4-1E3C-4FDD-BD02-AC6445D3D8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421A0-B32E-4A6A-A3FA-72BD297CDE5B}" type="datetimeFigureOut">
              <a:rPr lang="en-CA" smtClean="0"/>
              <a:t>2020-12-13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80ADFA8-47B2-4A1A-8569-206D40CC46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692DB71-4ED0-4402-8524-163046D591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E4E48F-5569-4F35-A202-B4371EAE21F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861532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D5E49D-3864-4062-9AA0-B8A4236020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059BEEA-15B0-4806-8879-674B2677348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F9B3ECF-7CF8-43F8-BDC7-A6C25720261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C7E98A1-03B0-4201-9CDB-667BDAD7C0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421A0-B32E-4A6A-A3FA-72BD297CDE5B}" type="datetimeFigureOut">
              <a:rPr lang="en-CA" smtClean="0"/>
              <a:t>2020-12-13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5A8C858-7B13-4724-8811-D82E62BD49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79C1463-0C49-40FE-B1F5-0D5DBA3427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E4E48F-5569-4F35-A202-B4371EAE21F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738056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B7F9E92-0D79-41E0-B459-199EDCB3E5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BEB0ECC-4993-4CA8-972C-790287B3F7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79F4CB8-C71E-4289-BCF5-467883B4A71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F421A0-B32E-4A6A-A3FA-72BD297CDE5B}" type="datetimeFigureOut">
              <a:rPr lang="en-CA" smtClean="0"/>
              <a:t>2020-12-13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486669-83ED-421E-BE48-85DAA1C31F5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380722-31A6-4DCC-8DA9-810F787CED5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E4E48F-5569-4F35-A202-B4371EAE21F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453710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val 1">
            <a:extLst>
              <a:ext uri="{FF2B5EF4-FFF2-40B4-BE49-F238E27FC236}">
                <a16:creationId xmlns:a16="http://schemas.microsoft.com/office/drawing/2014/main" id="{32EDA023-93F5-4CB1-BEA3-0510A020F738}"/>
              </a:ext>
            </a:extLst>
          </p:cNvPr>
          <p:cNvSpPr/>
          <p:nvPr/>
        </p:nvSpPr>
        <p:spPr>
          <a:xfrm>
            <a:off x="333775" y="2117282"/>
            <a:ext cx="1640056" cy="1235654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dirty="0"/>
          </a:p>
        </p:txBody>
      </p:sp>
      <p:sp>
        <p:nvSpPr>
          <p:cNvPr id="3" name="Oval 2">
            <a:extLst>
              <a:ext uri="{FF2B5EF4-FFF2-40B4-BE49-F238E27FC236}">
                <a16:creationId xmlns:a16="http://schemas.microsoft.com/office/drawing/2014/main" id="{973D423B-2D4A-4423-A386-4FCFD3A1A105}"/>
              </a:ext>
            </a:extLst>
          </p:cNvPr>
          <p:cNvSpPr/>
          <p:nvPr/>
        </p:nvSpPr>
        <p:spPr>
          <a:xfrm>
            <a:off x="339571" y="563206"/>
            <a:ext cx="1695452" cy="1197490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dirty="0"/>
          </a:p>
        </p:txBody>
      </p:sp>
      <p:sp>
        <p:nvSpPr>
          <p:cNvPr id="5" name="Oval 4">
            <a:extLst>
              <a:ext uri="{FF2B5EF4-FFF2-40B4-BE49-F238E27FC236}">
                <a16:creationId xmlns:a16="http://schemas.microsoft.com/office/drawing/2014/main" id="{50630653-ACAC-4BE3-AAFE-26B61E56098D}"/>
              </a:ext>
            </a:extLst>
          </p:cNvPr>
          <p:cNvSpPr/>
          <p:nvPr/>
        </p:nvSpPr>
        <p:spPr>
          <a:xfrm>
            <a:off x="323012" y="3763534"/>
            <a:ext cx="1713253" cy="1321215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dirty="0"/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49C7529C-5823-4E1A-8C44-533798891594}"/>
              </a:ext>
            </a:extLst>
          </p:cNvPr>
          <p:cNvSpPr/>
          <p:nvPr/>
        </p:nvSpPr>
        <p:spPr>
          <a:xfrm>
            <a:off x="2471106" y="2190841"/>
            <a:ext cx="1742169" cy="1470151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dirty="0"/>
          </a:p>
        </p:txBody>
      </p:sp>
      <p:sp>
        <p:nvSpPr>
          <p:cNvPr id="7" name="Oval 6">
            <a:extLst>
              <a:ext uri="{FF2B5EF4-FFF2-40B4-BE49-F238E27FC236}">
                <a16:creationId xmlns:a16="http://schemas.microsoft.com/office/drawing/2014/main" id="{BE2F52ED-0903-4A3E-BA73-7F86526D557D}"/>
              </a:ext>
            </a:extLst>
          </p:cNvPr>
          <p:cNvSpPr/>
          <p:nvPr/>
        </p:nvSpPr>
        <p:spPr>
          <a:xfrm>
            <a:off x="4322827" y="3479037"/>
            <a:ext cx="1801472" cy="1542502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2931B61-FBFB-456F-B893-772A7989B89C}"/>
              </a:ext>
            </a:extLst>
          </p:cNvPr>
          <p:cNvSpPr txBox="1"/>
          <p:nvPr/>
        </p:nvSpPr>
        <p:spPr>
          <a:xfrm>
            <a:off x="618669" y="958619"/>
            <a:ext cx="12675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Motivation</a:t>
            </a:r>
            <a:endParaRPr lang="en-CA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4A98152-728A-41FE-A872-FECE5ECD597F}"/>
              </a:ext>
            </a:extLst>
          </p:cNvPr>
          <p:cNvSpPr txBox="1"/>
          <p:nvPr/>
        </p:nvSpPr>
        <p:spPr>
          <a:xfrm>
            <a:off x="2608300" y="2457378"/>
            <a:ext cx="148342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Duration</a:t>
            </a:r>
          </a:p>
          <a:p>
            <a:pPr algn="ctr"/>
            <a:r>
              <a:rPr lang="en-US" dirty="0"/>
              <a:t>Of</a:t>
            </a:r>
          </a:p>
          <a:p>
            <a:pPr algn="ctr"/>
            <a:r>
              <a:rPr lang="en-US" dirty="0"/>
              <a:t>Participation</a:t>
            </a:r>
            <a:endParaRPr lang="en-CA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5D150A8-8D59-4E59-A87B-1BA92024B267}"/>
              </a:ext>
            </a:extLst>
          </p:cNvPr>
          <p:cNvSpPr txBox="1"/>
          <p:nvPr/>
        </p:nvSpPr>
        <p:spPr>
          <a:xfrm>
            <a:off x="547368" y="2290482"/>
            <a:ext cx="128445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Previous </a:t>
            </a:r>
          </a:p>
          <a:p>
            <a:pPr algn="ctr"/>
            <a:r>
              <a:rPr lang="en-US" dirty="0"/>
              <a:t>Treatment History</a:t>
            </a:r>
            <a:endParaRPr lang="en-CA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AFFEDF0-C808-48C7-B48E-8AE439DF6190}"/>
              </a:ext>
            </a:extLst>
          </p:cNvPr>
          <p:cNvSpPr txBox="1"/>
          <p:nvPr/>
        </p:nvSpPr>
        <p:spPr>
          <a:xfrm>
            <a:off x="618670" y="4188755"/>
            <a:ext cx="12675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SU severity</a:t>
            </a:r>
            <a:endParaRPr lang="en-CA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800805E-2E43-4481-8358-576C47F8BD8B}"/>
              </a:ext>
            </a:extLst>
          </p:cNvPr>
          <p:cNvSpPr txBox="1"/>
          <p:nvPr/>
        </p:nvSpPr>
        <p:spPr>
          <a:xfrm>
            <a:off x="4472643" y="3660992"/>
            <a:ext cx="141568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Ratings of Post-Ayahuasca Integration </a:t>
            </a:r>
            <a:endParaRPr lang="en-CA" dirty="0"/>
          </a:p>
        </p:txBody>
      </p:sp>
      <p:sp>
        <p:nvSpPr>
          <p:cNvPr id="16" name="Oval 15">
            <a:extLst>
              <a:ext uri="{FF2B5EF4-FFF2-40B4-BE49-F238E27FC236}">
                <a16:creationId xmlns:a16="http://schemas.microsoft.com/office/drawing/2014/main" id="{90D4993A-5FB7-4245-AC98-E49C0BED2F39}"/>
              </a:ext>
            </a:extLst>
          </p:cNvPr>
          <p:cNvSpPr/>
          <p:nvPr/>
        </p:nvSpPr>
        <p:spPr>
          <a:xfrm>
            <a:off x="4259401" y="856780"/>
            <a:ext cx="1730365" cy="1600598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2352B1B-7D43-4E81-9A90-A2152C2552B1}"/>
              </a:ext>
            </a:extLst>
          </p:cNvPr>
          <p:cNvSpPr txBox="1"/>
          <p:nvPr/>
        </p:nvSpPr>
        <p:spPr>
          <a:xfrm>
            <a:off x="4425235" y="1135841"/>
            <a:ext cx="134444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Ratings of Ayahuasca and </a:t>
            </a:r>
            <a:r>
              <a:rPr lang="en-US" dirty="0" err="1"/>
              <a:t>Dietas</a:t>
            </a:r>
            <a:endParaRPr lang="en-CA" dirty="0"/>
          </a:p>
        </p:txBody>
      </p:sp>
      <p:sp>
        <p:nvSpPr>
          <p:cNvPr id="18" name="Oval 17">
            <a:extLst>
              <a:ext uri="{FF2B5EF4-FFF2-40B4-BE49-F238E27FC236}">
                <a16:creationId xmlns:a16="http://schemas.microsoft.com/office/drawing/2014/main" id="{90A92AB7-AF24-44FB-8FDC-1F1C5626A362}"/>
              </a:ext>
            </a:extLst>
          </p:cNvPr>
          <p:cNvSpPr/>
          <p:nvPr/>
        </p:nvSpPr>
        <p:spPr>
          <a:xfrm>
            <a:off x="8721850" y="2918735"/>
            <a:ext cx="1742169" cy="1470151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dirty="0"/>
          </a:p>
        </p:txBody>
      </p:sp>
      <p:sp>
        <p:nvSpPr>
          <p:cNvPr id="19" name="Oval 18">
            <a:extLst>
              <a:ext uri="{FF2B5EF4-FFF2-40B4-BE49-F238E27FC236}">
                <a16:creationId xmlns:a16="http://schemas.microsoft.com/office/drawing/2014/main" id="{75E95A10-1AF9-4EC2-942D-D50FC2895087}"/>
              </a:ext>
            </a:extLst>
          </p:cNvPr>
          <p:cNvSpPr/>
          <p:nvPr/>
        </p:nvSpPr>
        <p:spPr>
          <a:xfrm>
            <a:off x="8654042" y="1150809"/>
            <a:ext cx="1742169" cy="1470151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E12D06C-5F21-4364-B904-9C661A8623F1}"/>
              </a:ext>
            </a:extLst>
          </p:cNvPr>
          <p:cNvSpPr txBox="1"/>
          <p:nvPr/>
        </p:nvSpPr>
        <p:spPr>
          <a:xfrm>
            <a:off x="8770946" y="1339011"/>
            <a:ext cx="148304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hange in </a:t>
            </a:r>
          </a:p>
          <a:p>
            <a:pPr algn="ctr"/>
            <a:r>
              <a:rPr lang="en-US" dirty="0"/>
              <a:t>90-day </a:t>
            </a:r>
          </a:p>
          <a:p>
            <a:pPr algn="ctr"/>
            <a:r>
              <a:rPr lang="en-US" dirty="0"/>
              <a:t>SU Symptom Count </a:t>
            </a:r>
            <a:endParaRPr lang="en-CA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55BF8AA-78C1-43B6-85C2-23C22291E30E}"/>
              </a:ext>
            </a:extLst>
          </p:cNvPr>
          <p:cNvSpPr txBox="1"/>
          <p:nvPr/>
        </p:nvSpPr>
        <p:spPr>
          <a:xfrm>
            <a:off x="8968492" y="3096056"/>
            <a:ext cx="126752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hange in WHO-Quality of Life </a:t>
            </a:r>
            <a:endParaRPr lang="en-CA" dirty="0"/>
          </a:p>
        </p:txBody>
      </p:sp>
      <p:sp>
        <p:nvSpPr>
          <p:cNvPr id="23" name="Oval 22">
            <a:extLst>
              <a:ext uri="{FF2B5EF4-FFF2-40B4-BE49-F238E27FC236}">
                <a16:creationId xmlns:a16="http://schemas.microsoft.com/office/drawing/2014/main" id="{57A4C771-E1EE-40FF-80A3-704590616600}"/>
              </a:ext>
            </a:extLst>
          </p:cNvPr>
          <p:cNvSpPr/>
          <p:nvPr/>
        </p:nvSpPr>
        <p:spPr>
          <a:xfrm>
            <a:off x="6289257" y="1395205"/>
            <a:ext cx="1714511" cy="1302111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21FC4A2-67E4-4592-B13E-C15BEC3AD6C8}"/>
              </a:ext>
            </a:extLst>
          </p:cNvPr>
          <p:cNvSpPr txBox="1"/>
          <p:nvPr/>
        </p:nvSpPr>
        <p:spPr>
          <a:xfrm>
            <a:off x="6471873" y="1610782"/>
            <a:ext cx="126752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hange in WHO Spirituality</a:t>
            </a:r>
            <a:endParaRPr lang="en-CA" dirty="0"/>
          </a:p>
        </p:txBody>
      </p:sp>
      <p:sp>
        <p:nvSpPr>
          <p:cNvPr id="25" name="Arrow: Right 24">
            <a:extLst>
              <a:ext uri="{FF2B5EF4-FFF2-40B4-BE49-F238E27FC236}">
                <a16:creationId xmlns:a16="http://schemas.microsoft.com/office/drawing/2014/main" id="{47AA5273-B307-4D4A-8F41-E3A3E9336BDA}"/>
              </a:ext>
            </a:extLst>
          </p:cNvPr>
          <p:cNvSpPr/>
          <p:nvPr/>
        </p:nvSpPr>
        <p:spPr>
          <a:xfrm rot="1770058">
            <a:off x="1943116" y="1525817"/>
            <a:ext cx="857319" cy="374579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26" name="Arrow: Right 25">
            <a:extLst>
              <a:ext uri="{FF2B5EF4-FFF2-40B4-BE49-F238E27FC236}">
                <a16:creationId xmlns:a16="http://schemas.microsoft.com/office/drawing/2014/main" id="{379CFCDA-D793-41B6-8C7E-6E3FA8672568}"/>
              </a:ext>
            </a:extLst>
          </p:cNvPr>
          <p:cNvSpPr/>
          <p:nvPr/>
        </p:nvSpPr>
        <p:spPr>
          <a:xfrm rot="2419270">
            <a:off x="5516307" y="2807791"/>
            <a:ext cx="1182051" cy="31649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27" name="Arrow: Right 26">
            <a:extLst>
              <a:ext uri="{FF2B5EF4-FFF2-40B4-BE49-F238E27FC236}">
                <a16:creationId xmlns:a16="http://schemas.microsoft.com/office/drawing/2014/main" id="{CF825AF0-B401-4C54-A90C-33E99491E178}"/>
              </a:ext>
            </a:extLst>
          </p:cNvPr>
          <p:cNvSpPr/>
          <p:nvPr/>
        </p:nvSpPr>
        <p:spPr>
          <a:xfrm rot="19472148">
            <a:off x="3254645" y="1632829"/>
            <a:ext cx="729893" cy="330689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28" name="Arrow: Right 27">
            <a:extLst>
              <a:ext uri="{FF2B5EF4-FFF2-40B4-BE49-F238E27FC236}">
                <a16:creationId xmlns:a16="http://schemas.microsoft.com/office/drawing/2014/main" id="{02CBCF46-FBE9-4DF5-A29A-0538A176F0B0}"/>
              </a:ext>
            </a:extLst>
          </p:cNvPr>
          <p:cNvSpPr/>
          <p:nvPr/>
        </p:nvSpPr>
        <p:spPr>
          <a:xfrm rot="21432152">
            <a:off x="1968965" y="2657843"/>
            <a:ext cx="377840" cy="349267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29" name="Arrow: Right 28">
            <a:extLst>
              <a:ext uri="{FF2B5EF4-FFF2-40B4-BE49-F238E27FC236}">
                <a16:creationId xmlns:a16="http://schemas.microsoft.com/office/drawing/2014/main" id="{24168872-20A1-40BE-B50A-FA49B122475C}"/>
              </a:ext>
            </a:extLst>
          </p:cNvPr>
          <p:cNvSpPr/>
          <p:nvPr/>
        </p:nvSpPr>
        <p:spPr>
          <a:xfrm rot="19195892">
            <a:off x="2003932" y="3671932"/>
            <a:ext cx="796430" cy="332897"/>
          </a:xfrm>
          <a:prstGeom prst="rightArrow">
            <a:avLst>
              <a:gd name="adj1" fmla="val 50000"/>
              <a:gd name="adj2" fmla="val 40125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31" name="Oval 30">
            <a:extLst>
              <a:ext uri="{FF2B5EF4-FFF2-40B4-BE49-F238E27FC236}">
                <a16:creationId xmlns:a16="http://schemas.microsoft.com/office/drawing/2014/main" id="{F0E1A044-7BE5-46D7-9AB2-159379D9C395}"/>
              </a:ext>
            </a:extLst>
          </p:cNvPr>
          <p:cNvSpPr/>
          <p:nvPr/>
        </p:nvSpPr>
        <p:spPr>
          <a:xfrm>
            <a:off x="6388018" y="3228548"/>
            <a:ext cx="1714511" cy="1302111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A97F08C9-FED8-4C82-B7BD-AF780C278B8A}"/>
              </a:ext>
            </a:extLst>
          </p:cNvPr>
          <p:cNvSpPr txBox="1"/>
          <p:nvPr/>
        </p:nvSpPr>
        <p:spPr>
          <a:xfrm>
            <a:off x="6705039" y="3402612"/>
            <a:ext cx="126752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hange in ASI- MH Severity</a:t>
            </a:r>
            <a:endParaRPr lang="en-CA" dirty="0"/>
          </a:p>
        </p:txBody>
      </p:sp>
      <p:sp>
        <p:nvSpPr>
          <p:cNvPr id="33" name="Arrow: Right 32">
            <a:extLst>
              <a:ext uri="{FF2B5EF4-FFF2-40B4-BE49-F238E27FC236}">
                <a16:creationId xmlns:a16="http://schemas.microsoft.com/office/drawing/2014/main" id="{40E41187-FCE2-44A9-8E70-D8B9E3EAA8FF}"/>
              </a:ext>
            </a:extLst>
          </p:cNvPr>
          <p:cNvSpPr/>
          <p:nvPr/>
        </p:nvSpPr>
        <p:spPr>
          <a:xfrm rot="18921329">
            <a:off x="5523418" y="2873250"/>
            <a:ext cx="1120072" cy="30821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35" name="Arrow: Right 34">
            <a:extLst>
              <a:ext uri="{FF2B5EF4-FFF2-40B4-BE49-F238E27FC236}">
                <a16:creationId xmlns:a16="http://schemas.microsoft.com/office/drawing/2014/main" id="{F579B330-F398-445C-A76B-C79539C2B17F}"/>
              </a:ext>
            </a:extLst>
          </p:cNvPr>
          <p:cNvSpPr/>
          <p:nvPr/>
        </p:nvSpPr>
        <p:spPr>
          <a:xfrm rot="1691599">
            <a:off x="5949582" y="1747521"/>
            <a:ext cx="316445" cy="33876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36" name="Arrow: Right 35">
            <a:extLst>
              <a:ext uri="{FF2B5EF4-FFF2-40B4-BE49-F238E27FC236}">
                <a16:creationId xmlns:a16="http://schemas.microsoft.com/office/drawing/2014/main" id="{87710EB6-32B5-467D-ACCD-8C5C5D5D6362}"/>
              </a:ext>
            </a:extLst>
          </p:cNvPr>
          <p:cNvSpPr/>
          <p:nvPr/>
        </p:nvSpPr>
        <p:spPr>
          <a:xfrm rot="19297508">
            <a:off x="4093833" y="2118130"/>
            <a:ext cx="394834" cy="34263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37" name="Arrow: Right 36">
            <a:extLst>
              <a:ext uri="{FF2B5EF4-FFF2-40B4-BE49-F238E27FC236}">
                <a16:creationId xmlns:a16="http://schemas.microsoft.com/office/drawing/2014/main" id="{E801E2A9-175D-47E9-9E38-35B873189019}"/>
              </a:ext>
            </a:extLst>
          </p:cNvPr>
          <p:cNvSpPr/>
          <p:nvPr/>
        </p:nvSpPr>
        <p:spPr>
          <a:xfrm rot="1772473">
            <a:off x="7768953" y="2658466"/>
            <a:ext cx="1206465" cy="353497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38" name="Arrow: Right 37">
            <a:extLst>
              <a:ext uri="{FF2B5EF4-FFF2-40B4-BE49-F238E27FC236}">
                <a16:creationId xmlns:a16="http://schemas.microsoft.com/office/drawing/2014/main" id="{6DD7F968-8523-4ADB-A877-28231980E82F}"/>
              </a:ext>
            </a:extLst>
          </p:cNvPr>
          <p:cNvSpPr/>
          <p:nvPr/>
        </p:nvSpPr>
        <p:spPr>
          <a:xfrm rot="21359635">
            <a:off x="8161607" y="3586786"/>
            <a:ext cx="447354" cy="353497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39" name="Arrow: Right 38">
            <a:extLst>
              <a:ext uri="{FF2B5EF4-FFF2-40B4-BE49-F238E27FC236}">
                <a16:creationId xmlns:a16="http://schemas.microsoft.com/office/drawing/2014/main" id="{C86689F4-8C38-45CC-968B-C0FDAFD04527}"/>
              </a:ext>
            </a:extLst>
          </p:cNvPr>
          <p:cNvSpPr/>
          <p:nvPr/>
        </p:nvSpPr>
        <p:spPr>
          <a:xfrm rot="19784670">
            <a:off x="7590760" y="2643090"/>
            <a:ext cx="1319018" cy="378773"/>
          </a:xfrm>
          <a:prstGeom prst="rightArrow">
            <a:avLst>
              <a:gd name="adj1" fmla="val 44104"/>
              <a:gd name="adj2" fmla="val 50000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40" name="Arrow: Right 39">
            <a:extLst>
              <a:ext uri="{FF2B5EF4-FFF2-40B4-BE49-F238E27FC236}">
                <a16:creationId xmlns:a16="http://schemas.microsoft.com/office/drawing/2014/main" id="{029AFBB4-45B6-4E57-B6AC-E79C4E1A8B66}"/>
              </a:ext>
            </a:extLst>
          </p:cNvPr>
          <p:cNvSpPr/>
          <p:nvPr/>
        </p:nvSpPr>
        <p:spPr>
          <a:xfrm rot="21359635">
            <a:off x="8132944" y="1855832"/>
            <a:ext cx="447354" cy="353497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41" name="Arrow: Right 40">
            <a:extLst>
              <a:ext uri="{FF2B5EF4-FFF2-40B4-BE49-F238E27FC236}">
                <a16:creationId xmlns:a16="http://schemas.microsoft.com/office/drawing/2014/main" id="{91A21E97-A5EA-419F-B0BB-20AFC258DFE0}"/>
              </a:ext>
            </a:extLst>
          </p:cNvPr>
          <p:cNvSpPr/>
          <p:nvPr/>
        </p:nvSpPr>
        <p:spPr>
          <a:xfrm rot="1701350">
            <a:off x="4035937" y="3440009"/>
            <a:ext cx="394834" cy="34263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42" name="Arrow: Right 41">
            <a:extLst>
              <a:ext uri="{FF2B5EF4-FFF2-40B4-BE49-F238E27FC236}">
                <a16:creationId xmlns:a16="http://schemas.microsoft.com/office/drawing/2014/main" id="{9831CA40-82B0-4176-B996-45005FD24E20}"/>
              </a:ext>
            </a:extLst>
          </p:cNvPr>
          <p:cNvSpPr/>
          <p:nvPr/>
        </p:nvSpPr>
        <p:spPr>
          <a:xfrm rot="19364466">
            <a:off x="6093199" y="4098759"/>
            <a:ext cx="316445" cy="33876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205795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7</TotalTime>
  <Words>38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ian rush</dc:creator>
  <cp:lastModifiedBy>brian rush</cp:lastModifiedBy>
  <cp:revision>3</cp:revision>
  <dcterms:created xsi:type="dcterms:W3CDTF">2020-12-13T21:03:59Z</dcterms:created>
  <dcterms:modified xsi:type="dcterms:W3CDTF">2020-12-13T22:21:38Z</dcterms:modified>
</cp:coreProperties>
</file>